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9144000" cy="6858000" type="screen4x3"/>
  <p:notesSz cx="6797675" cy="9926638"/>
  <p:custDataLst>
    <p:tags r:id="rId4"/>
  </p:custDataLst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1644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cs typeface="Arial" charset="0"/>
              </a:defRPr>
            </a:lvl1pPr>
          </a:lstStyle>
          <a:p>
            <a:pPr>
              <a:defRPr/>
            </a:pPr>
            <a:fld id="{B49C56FE-0D9C-C74B-A2DD-6CC496BDED3F}" type="datetimeFigureOut">
              <a:rPr lang="de-CH"/>
              <a:pPr>
                <a:defRPr/>
              </a:pPr>
              <a:t>07.01.2015</a:t>
            </a:fld>
            <a:endParaRPr lang="de-CH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de-CH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de-CH" noProof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cs typeface="Arial" charset="0"/>
              </a:defRPr>
            </a:lvl1pPr>
          </a:lstStyle>
          <a:p>
            <a:pPr>
              <a:defRPr/>
            </a:pPr>
            <a:fld id="{616D9032-4B03-7849-B82F-EA6A7A8C379E}" type="slidenum">
              <a:rPr lang="de-CH"/>
              <a:pPr>
                <a:defRPr/>
              </a:pPr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857256017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ＭＳ Ｐゴシック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21C1C8E-384F-FB4C-9A9E-E059F7E96B33}" type="datetimeFigureOut">
              <a:rPr lang="de-CH"/>
              <a:pPr>
                <a:defRPr/>
              </a:pPr>
              <a:t>07.01.201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53153CD-BA0F-6B46-8135-123D674FB7A7}" type="slidenum">
              <a:rPr lang="de-CH"/>
              <a:pPr>
                <a:defRPr/>
              </a:pPr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3824907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F6D5AE-A47D-3044-B603-891790B57F59}" type="datetimeFigureOut">
              <a:rPr lang="de-CH"/>
              <a:pPr>
                <a:defRPr/>
              </a:pPr>
              <a:t>07.01.201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67AB28-6438-C844-A641-8705107B422B}" type="slidenum">
              <a:rPr lang="de-CH"/>
              <a:pPr>
                <a:defRPr/>
              </a:pPr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585987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3B5872-BB9F-F84C-AB4C-CAAD534B4841}" type="datetimeFigureOut">
              <a:rPr lang="de-CH"/>
              <a:pPr>
                <a:defRPr/>
              </a:pPr>
              <a:t>07.01.201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3AEFD1-7CFA-5948-B71D-DEEE28BF25C0}" type="slidenum">
              <a:rPr lang="de-CH"/>
              <a:pPr>
                <a:defRPr/>
              </a:pPr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2086311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E4BC49-C48D-E44D-B212-B6CB2B09C659}" type="datetimeFigureOut">
              <a:rPr lang="de-CH"/>
              <a:pPr>
                <a:defRPr/>
              </a:pPr>
              <a:t>07.01.201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D1919C3-4306-C747-B22D-9E96978FFB52}" type="slidenum">
              <a:rPr lang="de-CH"/>
              <a:pPr>
                <a:defRPr/>
              </a:pPr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9929805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E5E76AF-F1AA-D446-89E8-2ADDD53A6E6B}" type="datetimeFigureOut">
              <a:rPr lang="de-CH"/>
              <a:pPr>
                <a:defRPr/>
              </a:pPr>
              <a:t>07.01.201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F941B9-992A-2D41-BA84-9E2D1A7DCE26}" type="slidenum">
              <a:rPr lang="de-CH"/>
              <a:pPr>
                <a:defRPr/>
              </a:pPr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661783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9C9370-E80C-D441-8247-7CE50B4B2E73}" type="datetimeFigureOut">
              <a:rPr lang="de-CH"/>
              <a:pPr>
                <a:defRPr/>
              </a:pPr>
              <a:t>07.01.2015</a:t>
            </a:fld>
            <a:endParaRPr lang="de-CH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A5EA46-6987-B94A-BA7E-98400704A7D6}" type="slidenum">
              <a:rPr lang="de-CH"/>
              <a:pPr>
                <a:defRPr/>
              </a:pPr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3781485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8F0F4C-1475-B240-AA26-B28A2A80C79A}" type="datetimeFigureOut">
              <a:rPr lang="de-CH"/>
              <a:pPr>
                <a:defRPr/>
              </a:pPr>
              <a:t>07.01.2015</a:t>
            </a:fld>
            <a:endParaRPr lang="de-CH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75C44C-1BA0-9642-B9C9-41D1EA2B7C2D}" type="slidenum">
              <a:rPr lang="de-CH"/>
              <a:pPr>
                <a:defRPr/>
              </a:pPr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7676757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3BDB38A-F1C9-F946-8992-58F11ACB9F18}" type="datetimeFigureOut">
              <a:rPr lang="de-CH"/>
              <a:pPr>
                <a:defRPr/>
              </a:pPr>
              <a:t>07.01.2015</a:t>
            </a:fld>
            <a:endParaRPr lang="de-CH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F48D48-BCB5-4C48-B7F4-9305BB294C7C}" type="slidenum">
              <a:rPr lang="de-CH"/>
              <a:pPr>
                <a:defRPr/>
              </a:pPr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5702933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2D19FF-5C62-7444-BAB7-9B156A852F07}" type="datetimeFigureOut">
              <a:rPr lang="de-CH"/>
              <a:pPr>
                <a:defRPr/>
              </a:pPr>
              <a:t>07.01.2015</a:t>
            </a:fld>
            <a:endParaRPr lang="de-CH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AB3927-CEAE-D540-9357-88951B19E49A}" type="slidenum">
              <a:rPr lang="de-CH"/>
              <a:pPr>
                <a:defRPr/>
              </a:pPr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6745378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D56233D-16E9-2D44-AED2-9B89C14005BD}" type="datetimeFigureOut">
              <a:rPr lang="de-CH"/>
              <a:pPr>
                <a:defRPr/>
              </a:pPr>
              <a:t>07.01.2015</a:t>
            </a:fld>
            <a:endParaRPr lang="de-CH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DE911A0-E191-EC49-A2B6-F39B69B249D1}" type="slidenum">
              <a:rPr lang="de-CH"/>
              <a:pPr>
                <a:defRPr/>
              </a:pPr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6699128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CH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F695A34-992B-2B48-8C5F-490C5925C01C}" type="datetimeFigureOut">
              <a:rPr lang="de-CH"/>
              <a:pPr>
                <a:defRPr/>
              </a:pPr>
              <a:t>07.01.2015</a:t>
            </a:fld>
            <a:endParaRPr lang="de-CH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174AFE-87BC-5F49-BE78-BAD43C64D4C8}" type="slidenum">
              <a:rPr lang="de-CH"/>
              <a:pPr>
                <a:defRPr/>
              </a:pPr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9461746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  <a:endParaRPr lang="de-CH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  <a:cs typeface="Arial" charset="0"/>
              </a:defRPr>
            </a:lvl1pPr>
          </a:lstStyle>
          <a:p>
            <a:pPr>
              <a:defRPr/>
            </a:pPr>
            <a:fld id="{3AA7F55C-B592-994E-85C7-D4A135FE45C5}" type="datetimeFigureOut">
              <a:rPr lang="de-CH"/>
              <a:pPr>
                <a:defRPr/>
              </a:pPr>
              <a:t>07.01.201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cs typeface="Arial" charset="0"/>
              </a:defRPr>
            </a:lvl1pPr>
          </a:lstStyle>
          <a:p>
            <a:pPr>
              <a:defRPr/>
            </a:pPr>
            <a:fld id="{2ED318BE-A981-B64C-8A29-B4B80A5084C4}" type="slidenum">
              <a:rPr lang="de-CH"/>
              <a:pPr>
                <a:defRPr/>
              </a:pPr>
              <a:t>‹#›</a:t>
            </a:fld>
            <a:endParaRPr lang="de-CH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charset="0"/>
          <a:cs typeface="ＭＳ Ｐゴシック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ＭＳ Ｐゴシック" charset="0"/>
          <a:cs typeface="ＭＳ Ｐゴシック" charset="0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ＭＳ Ｐゴシック" charset="0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ＭＳ Ｐゴシック" charset="0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"/>
          <p:cNvSpPr txBox="1">
            <a:spLocks noChangeArrowheads="1"/>
          </p:cNvSpPr>
          <p:nvPr/>
        </p:nvSpPr>
        <p:spPr bwMode="auto">
          <a:xfrm>
            <a:off x="1187624" y="332656"/>
            <a:ext cx="115721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sz="1200">
                <a:latin typeface="Arial"/>
                <a:cs typeface="Arial"/>
              </a:rPr>
              <a:t>Suppl. Table 2 </a:t>
            </a: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80836253"/>
              </p:ext>
            </p:extLst>
          </p:nvPr>
        </p:nvGraphicFramePr>
        <p:xfrm>
          <a:off x="1187624" y="836712"/>
          <a:ext cx="6984776" cy="56388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936104"/>
                <a:gridCol w="2952328"/>
                <a:gridCol w="216024"/>
                <a:gridCol w="2880320"/>
              </a:tblGrid>
              <a:tr h="183620">
                <a:tc>
                  <a:txBody>
                    <a:bodyPr/>
                    <a:lstStyle/>
                    <a:p>
                      <a:r>
                        <a:rPr kumimoji="0" lang="en-US" sz="10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Plasmid</a:t>
                      </a:r>
                      <a:endParaRPr lang="en-US" sz="100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0" lang="de-CH" sz="10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Forward</a:t>
                      </a:r>
                      <a:endParaRPr lang="en-US" sz="100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00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0" lang="de-CH" sz="10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Reverse</a:t>
                      </a:r>
                      <a:endParaRPr lang="en-US" sz="100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83620">
                <a:tc>
                  <a:txBody>
                    <a:bodyPr/>
                    <a:lstStyle/>
                    <a:p>
                      <a:r>
                        <a:rPr kumimoji="0" lang="de-CH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Whole </a:t>
                      </a:r>
                      <a:r>
                        <a:rPr kumimoji="0" lang="de-CH" sz="800" b="1" i="1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Lif</a:t>
                      </a:r>
                      <a:r>
                        <a:rPr kumimoji="0" lang="de-CH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 </a:t>
                      </a:r>
                      <a:r>
                        <a:rPr kumimoji="0" lang="en-US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3`UTR </a:t>
                      </a:r>
                      <a:endParaRPr lang="en-US" sz="800" b="1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GACCAATATCACCCGGGACCAGAA</a:t>
                      </a:r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0" lang="de-CH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TTAATCTAGATCAACAAGAAtGAGTTCTTTATTATTTCATTTTT</a:t>
                      </a:r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83620">
                <a:tc>
                  <a:txBody>
                    <a:bodyPr/>
                    <a:lstStyle/>
                    <a:p>
                      <a:r>
                        <a:rPr kumimoji="0" lang="de-CH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hgen DNA</a:t>
                      </a:r>
                      <a:endParaRPr lang="en-US" sz="800" b="1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TTAATCTAGAGCAAAGGGGAGAACAAGATAAGAT</a:t>
                      </a:r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0" lang="de-CH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TTAATCTAGAGCAGGCAAGGCAGTGGAG</a:t>
                      </a:r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8362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CH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AU-rich R I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GACCAATATCACCCGGGACCAGAA</a:t>
                      </a:r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0" lang="de-CH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TTAATCTAGAGTACCCTTCCACCCACAAAA</a:t>
                      </a:r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83620">
                <a:tc>
                  <a:txBody>
                    <a:bodyPr/>
                    <a:lstStyle/>
                    <a:p>
                      <a:r>
                        <a:rPr kumimoji="0" lang="de-CH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hACTB</a:t>
                      </a:r>
                      <a:r>
                        <a:rPr kumimoji="0" lang="en-US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 3`UTR </a:t>
                      </a:r>
                      <a:endParaRPr lang="en-US" sz="800" b="1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TTAATCTAGAGCGGACTATGACTTAGTTGCGTTACACCCTTTCTT</a:t>
                      </a:r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0" lang="de-CH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TTAATCTAGATCATTTTTAAGGTGTGCACTTTTATTCAACTGGTCTCA</a:t>
                      </a:r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83620">
                <a:tc>
                  <a:txBody>
                    <a:bodyPr/>
                    <a:lstStyle/>
                    <a:p>
                      <a:r>
                        <a:rPr kumimoji="0" lang="en-US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R32</a:t>
                      </a:r>
                      <a:endParaRPr lang="en-US" sz="800" b="1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TTAACTGCAGGATCCCGACTCAAGCAACC</a:t>
                      </a:r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0" lang="de-CH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TTAATCTAGACAAAGGAAAGGAAAGAGGGAGAGC</a:t>
                      </a:r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83620">
                <a:tc>
                  <a:txBody>
                    <a:bodyPr/>
                    <a:lstStyle/>
                    <a:p>
                      <a:r>
                        <a:rPr kumimoji="0" lang="en-US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R31</a:t>
                      </a:r>
                      <a:endParaRPr lang="en-US" sz="800" b="1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TTAACTGCAGCCAGAACCATTGAGCCTTTGGGGAAAACAGACTTTAGGGGCAGGTAG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0" lang="de-CH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TTAATCTAGATCGGGATCAAGGACACAGAA</a:t>
                      </a:r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83620">
                <a:tc>
                  <a:txBody>
                    <a:bodyPr/>
                    <a:lstStyle/>
                    <a:p>
                      <a:r>
                        <a:rPr kumimoji="0" lang="en-US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R38</a:t>
                      </a:r>
                      <a:endParaRPr lang="en-US" sz="800" b="1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0" lang="nl-NL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TTAACTGCAGGGGCGGTCCTTAGCAGTTCAGC</a:t>
                      </a:r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0" lang="sv-SE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TTAATCTAGAGGCCCCCACCATAGTCTCCT</a:t>
                      </a:r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8362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R36 (wt)</a:t>
                      </a:r>
                      <a:endParaRPr kumimoji="0" lang="de-CH" sz="8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/>
                        <a:ea typeface="ＭＳ Ｐゴシック" charset="0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TTAACTGCAGTGGAGCATGGAGAAGCAGAAC</a:t>
                      </a:r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TTAATCTAGAGGAAGGAGCCTCATACCATTT</a:t>
                      </a:r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83620">
                <a:tc>
                  <a:txBody>
                    <a:bodyPr/>
                    <a:lstStyle/>
                    <a:p>
                      <a:r>
                        <a:rPr kumimoji="0" lang="en-US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R35</a:t>
                      </a:r>
                      <a:endParaRPr lang="en-US" sz="800" b="1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TTAACTGCAGACCCCTACAGAGTCACCA</a:t>
                      </a:r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TTAATCTAGAGTACCCTTCCACCCACAAAA</a:t>
                      </a:r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83620">
                <a:tc>
                  <a:txBody>
                    <a:bodyPr/>
                    <a:lstStyle/>
                    <a:p>
                      <a:r>
                        <a:rPr kumimoji="0" lang="en-US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R37</a:t>
                      </a:r>
                      <a:endParaRPr lang="en-US" sz="800" b="1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TTAACTGCAGAGGGGGCTCAAAATGTGC</a:t>
                      </a:r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TTAATCTAGAGCTGGTGCTGGGCTGTAT</a:t>
                      </a:r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8362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Times" charset="0"/>
                          <a:cs typeface="Arial"/>
                        </a:rPr>
                        <a:t>R27-B </a:t>
                      </a:r>
                      <a:endParaRPr kumimoji="0" lang="de-CH" sz="8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/>
                        <a:ea typeface="Times" charset="0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GGCTTATTCAATGTCATATTTAAAATA</a:t>
                      </a:r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0" lang="de-CH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CTAGTATTTTAAATATGACATTGAATAAGCCGC</a:t>
                      </a:r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83620">
                <a:tc>
                  <a:txBody>
                    <a:bodyPr/>
                    <a:lstStyle/>
                    <a:p>
                      <a:r>
                        <a:rPr kumimoji="0" lang="en-US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Times" charset="0"/>
                          <a:cs typeface="Arial"/>
                        </a:rPr>
                        <a:t>R27-C</a:t>
                      </a:r>
                      <a:endParaRPr lang="en-US" sz="800" b="1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GGGAATGTTTCATACTGACAGATTACCGCGGCTTATTCAATGTCCTGCAGG</a:t>
                      </a:r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de-CH" sz="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/>
                        <a:ea typeface="ＭＳ Ｐゴシック" charset="0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CH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CCTGCAGGACATTGAATAAGCCGCGGTAATCTGTCAGTATGAAACATTCC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83620">
                <a:tc>
                  <a:txBody>
                    <a:bodyPr/>
                    <a:lstStyle/>
                    <a:p>
                      <a:r>
                        <a:rPr kumimoji="0" lang="en-US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Times" charset="0"/>
                          <a:cs typeface="Arial"/>
                        </a:rPr>
                        <a:t>R27-No /R27-A</a:t>
                      </a:r>
                      <a:endParaRPr lang="en-US" sz="800" b="1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0" lang="de-CH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Times" charset="0"/>
                          <a:cs typeface="Arial"/>
                        </a:rPr>
                        <a:t>GCTTATTCAATGTCCTGCAGGAAATACTAGTTGCGCATACTGAAGG</a:t>
                      </a:r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0" lang="de-CH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CCTTCAGTATGCGCAACTAGTATTTCCTGCAGGACATTGAATAAGC</a:t>
                      </a:r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8362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CH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Times" charset="0"/>
                          <a:cs typeface="Arial"/>
                        </a:rPr>
                        <a:t>R27  2 AR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0" lang="de-CH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Times" charset="0"/>
                          <a:cs typeface="Arial"/>
                        </a:rPr>
                        <a:t>CAGATTATTTTTATTTATTCAATGTCCTGCAGGAAATATTTATTTTTTATACTGAAGG</a:t>
                      </a:r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0" lang="de-CH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CCTTCAGTATAAAAAATAAATATTTCCTGCAGGACATTGAATAAATAAAAATAATCTG</a:t>
                      </a:r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8362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Times" charset="0"/>
                          <a:cs typeface="Arial"/>
                        </a:rPr>
                        <a:t>R36-DE</a:t>
                      </a:r>
                      <a:endParaRPr kumimoji="0" lang="de-CH" sz="8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/>
                        <a:ea typeface="Times" charset="0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CH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GTCCTATTTATATTAACTTATGCCGCGCTTAAATGGCAAAGTTAATTCCCCG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0" lang="de-CH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CGGGGAATTAACTTTGCCATTTAAGCGCGGCATAAGTTAATATAAATAGGAC</a:t>
                      </a:r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8362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Times" charset="0"/>
                          <a:cs typeface="Arial"/>
                        </a:rPr>
                        <a:t>R36-D</a:t>
                      </a:r>
                      <a:endParaRPr kumimoji="0" lang="de-CH" sz="8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/>
                        <a:ea typeface="Times" charset="0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CCAGCACAGCTGTCTATTTATTACTATGTCC</a:t>
                      </a:r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0" lang="de-CH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GGACATAGTAATAAATAGACAGCTGTGCTGG</a:t>
                      </a:r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83620">
                <a:tc>
                  <a:txBody>
                    <a:bodyPr/>
                    <a:lstStyle/>
                    <a:p>
                      <a:r>
                        <a:rPr kumimoji="0" lang="en-US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Times" charset="0"/>
                          <a:cs typeface="Arial"/>
                        </a:rPr>
                        <a:t>R36-No/R36-E</a:t>
                      </a:r>
                      <a:endParaRPr lang="en-US" sz="800" b="1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GCACAGCTGACTAGTCATTACTATGTCCTAGCGCTATTAACTTATGCCGCG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CH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GCGCGGCATAAGTTAATAGCGCTAGGACATAGTAATGACTAGTCAGCTGTGC</a:t>
                      </a:r>
                    </a:p>
                    <a:p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8362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Times" charset="0"/>
                          <a:cs typeface="Arial"/>
                        </a:rPr>
                        <a:t>R27 T7</a:t>
                      </a:r>
                      <a:endParaRPr kumimoji="0" lang="de-CH" sz="8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/>
                        <a:ea typeface="Times" charset="0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TTAATAATACGACTCACTATAGGGGACTTGGCCTTGGGTGA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0" lang="de-CH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TTAATCTAGATCAACAAGAATGAGTTCTTTATTATTTCATTTTT</a:t>
                      </a:r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8362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Times" charset="0"/>
                          <a:cs typeface="Arial"/>
                        </a:rPr>
                        <a:t>R36 T7</a:t>
                      </a:r>
                      <a:endParaRPr kumimoji="0" lang="de-CH" sz="8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/>
                        <a:ea typeface="Times" charset="0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TTAATAATACGACTCACTATAGGGTGGAGCATGGAGAAGCAGAA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/>
                        <a:ea typeface="ＭＳ Ｐゴシック" charset="0"/>
                        <a:cs typeface="Arial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TTAATCTAGAGGAAGGAGCCTCATACCATTT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6668084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PRESGUID" val="24a27946-27ce-4cce-937e-4fb1055063d8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9</Words>
  <Application>Microsoft Office PowerPoint</Application>
  <PresentationFormat>On-screen Show (4:3)</PresentationFormat>
  <Paragraphs>6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Times</vt:lpstr>
      <vt:lpstr>Office Theme</vt:lpstr>
      <vt:lpstr>PowerPoint Presentation</vt:lpstr>
    </vt:vector>
  </TitlesOfParts>
  <Company>Inselspita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gca, Cavit</dc:creator>
  <cp:lastModifiedBy>cavit agca</cp:lastModifiedBy>
  <cp:revision>79</cp:revision>
  <cp:lastPrinted>2014-06-19T09:40:11Z</cp:lastPrinted>
  <dcterms:created xsi:type="dcterms:W3CDTF">2014-04-10T08:05:20Z</dcterms:created>
  <dcterms:modified xsi:type="dcterms:W3CDTF">2015-01-07T09:36:09Z</dcterms:modified>
</cp:coreProperties>
</file>